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95CF7B02-0090-489B-A471-09E1E69A10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>
            <a:extLst>
              <a:ext uri="{FF2B5EF4-FFF2-40B4-BE49-F238E27FC236}">
                <a16:creationId xmlns:a16="http://schemas.microsoft.com/office/drawing/2014/main" id="{E2FC8886-BDAE-4C9A-84EA-D51DEDB2011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846F18A1-B89F-40E3-A4A8-0852FA55EC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01CA4-98A9-491D-ADB4-32051F4F8A4B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E29FA9BD-C536-4DBB-B2BF-394103CC20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EA7E0E01-735A-4BCD-8895-2E2C70F08E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69B0D-3364-4BA1-B72E-2835A34ED18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9199995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BC8505F1-B708-445F-B8BD-CF5417939B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:a16="http://schemas.microsoft.com/office/drawing/2014/main" id="{F9D0F968-08B4-4FA0-9ACF-BCCDE7B3A9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FDA01D8F-A994-4ED2-B430-08CEB5408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01CA4-98A9-491D-ADB4-32051F4F8A4B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ECA99459-EF5F-4EA7-9CA6-06E1F7ABEA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72D79448-E30C-416B-892F-7E145B0340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69B0D-3364-4BA1-B72E-2835A34ED18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03845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>
            <a:extLst>
              <a:ext uri="{FF2B5EF4-FFF2-40B4-BE49-F238E27FC236}">
                <a16:creationId xmlns:a16="http://schemas.microsoft.com/office/drawing/2014/main" id="{3B391EB9-655C-493C-BF1D-DAC387771A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:a16="http://schemas.microsoft.com/office/drawing/2014/main" id="{C625118C-A7D3-4A24-9CE8-6B08729136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63F33288-6C14-4C4B-84F5-FB44D87EC2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01CA4-98A9-491D-ADB4-32051F4F8A4B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285EE5CE-9087-4431-9063-9182BCD123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AE2ABF0E-B370-4136-AA67-3E8A379157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69B0D-3364-4BA1-B72E-2835A34ED18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8298115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B9758226-69B0-4042-A568-C6EA0AEFDF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id="{6D341CA8-077C-459A-AB17-5C4CE0DF089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698C4754-F790-4E7A-8C21-93034F14E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01CA4-98A9-491D-ADB4-32051F4F8A4B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5183D98F-5F97-46ED-B9DE-3349B1AFC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0AE0D7D9-54F4-4A90-A01F-8E96A6D4D3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69B0D-3364-4BA1-B72E-2835A34ED18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3763735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254D99A2-8D23-4EBE-B6A4-7A5FFADF44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:a16="http://schemas.microsoft.com/office/drawing/2014/main" id="{41122C3C-6E7C-4CDC-BEDD-675642FFEE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DFE9BA65-8A51-42E0-9912-FC3F4C7D74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01CA4-98A9-491D-ADB4-32051F4F8A4B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4DC335BA-705F-4038-AF63-742CA774D8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78CB3930-3B42-48E7-AD45-0DECEC0835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69B0D-3364-4BA1-B72E-2835A34ED18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9326774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B6B0EB00-C48F-41C6-A893-4A8B564989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id="{C83437E8-E5C4-4774-898D-44F7873AF86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:a16="http://schemas.microsoft.com/office/drawing/2014/main" id="{F35FDDED-1EC5-4FB0-B03A-A75DD0504F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:a16="http://schemas.microsoft.com/office/drawing/2014/main" id="{EC59B4A5-D6AC-41EB-9E4D-98B8D11F68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01CA4-98A9-491D-ADB4-32051F4F8A4B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:a16="http://schemas.microsoft.com/office/drawing/2014/main" id="{3334BB0C-7A23-46C1-A586-E25EAB9002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:a16="http://schemas.microsoft.com/office/drawing/2014/main" id="{C9F1AAE4-7A44-49D3-9827-B5AF5B8C8B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69B0D-3364-4BA1-B72E-2835A34ED18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5511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0BB9FF1A-89DC-4F7A-A292-449F14C918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:a16="http://schemas.microsoft.com/office/drawing/2014/main" id="{98E91508-ACF6-4497-B469-95029530CD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:a16="http://schemas.microsoft.com/office/drawing/2014/main" id="{6E6BFD9C-2B42-4787-8C82-C3F03BD741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>
            <a:extLst>
              <a:ext uri="{FF2B5EF4-FFF2-40B4-BE49-F238E27FC236}">
                <a16:creationId xmlns:a16="http://schemas.microsoft.com/office/drawing/2014/main" id="{48C4DD61-6083-4397-8B81-A0499C1D652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>
            <a:extLst>
              <a:ext uri="{FF2B5EF4-FFF2-40B4-BE49-F238E27FC236}">
                <a16:creationId xmlns:a16="http://schemas.microsoft.com/office/drawing/2014/main" id="{6FF4C42C-1895-4DF3-8E8C-48B274A8D7C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>
            <a:extLst>
              <a:ext uri="{FF2B5EF4-FFF2-40B4-BE49-F238E27FC236}">
                <a16:creationId xmlns:a16="http://schemas.microsoft.com/office/drawing/2014/main" id="{B50849DD-E7D6-46B8-BCF5-F3BD833A9E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01CA4-98A9-491D-ADB4-32051F4F8A4B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8" name="Нижний колонтитул 7">
            <a:extLst>
              <a:ext uri="{FF2B5EF4-FFF2-40B4-BE49-F238E27FC236}">
                <a16:creationId xmlns:a16="http://schemas.microsoft.com/office/drawing/2014/main" id="{7B91F0D7-15D0-4106-B004-1D37004848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>
            <a:extLst>
              <a:ext uri="{FF2B5EF4-FFF2-40B4-BE49-F238E27FC236}">
                <a16:creationId xmlns:a16="http://schemas.microsoft.com/office/drawing/2014/main" id="{6F004EAA-D3E6-4447-A0E7-708C5577CA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69B0D-3364-4BA1-B72E-2835A34ED18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95926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1D116F91-B81D-4F5D-9F0E-5FA5A20936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>
            <a:extLst>
              <a:ext uri="{FF2B5EF4-FFF2-40B4-BE49-F238E27FC236}">
                <a16:creationId xmlns:a16="http://schemas.microsoft.com/office/drawing/2014/main" id="{61062FE0-649A-4580-B813-A996724EB8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01CA4-98A9-491D-ADB4-32051F4F8A4B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4" name="Нижний колонтитул 3">
            <a:extLst>
              <a:ext uri="{FF2B5EF4-FFF2-40B4-BE49-F238E27FC236}">
                <a16:creationId xmlns:a16="http://schemas.microsoft.com/office/drawing/2014/main" id="{7F6EC5E3-F544-4BE3-8E3F-9F3A50C076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>
            <a:extLst>
              <a:ext uri="{FF2B5EF4-FFF2-40B4-BE49-F238E27FC236}">
                <a16:creationId xmlns:a16="http://schemas.microsoft.com/office/drawing/2014/main" id="{F575A35D-EB2D-4670-92DD-FDBC0F429F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69B0D-3364-4BA1-B72E-2835A34ED18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9716598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>
            <a:extLst>
              <a:ext uri="{FF2B5EF4-FFF2-40B4-BE49-F238E27FC236}">
                <a16:creationId xmlns:a16="http://schemas.microsoft.com/office/drawing/2014/main" id="{050E1F92-352B-4CCA-A866-86074245E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01CA4-98A9-491D-ADB4-32051F4F8A4B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3" name="Нижний колонтитул 2">
            <a:extLst>
              <a:ext uri="{FF2B5EF4-FFF2-40B4-BE49-F238E27FC236}">
                <a16:creationId xmlns:a16="http://schemas.microsoft.com/office/drawing/2014/main" id="{2DBBC09F-3B14-4C2A-B524-E3271D6677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>
            <a:extLst>
              <a:ext uri="{FF2B5EF4-FFF2-40B4-BE49-F238E27FC236}">
                <a16:creationId xmlns:a16="http://schemas.microsoft.com/office/drawing/2014/main" id="{2E10F6A9-5EB5-47E7-A686-84AD5DC176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69B0D-3364-4BA1-B72E-2835A34ED18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85412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8CD4B9B7-7113-4043-BCB5-AE1456C3C8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id="{7CD14618-C621-40EA-A515-B6B2C14C691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>
            <a:extLst>
              <a:ext uri="{FF2B5EF4-FFF2-40B4-BE49-F238E27FC236}">
                <a16:creationId xmlns:a16="http://schemas.microsoft.com/office/drawing/2014/main" id="{5B60227F-255C-48AF-ACD0-071B4ACE83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:a16="http://schemas.microsoft.com/office/drawing/2014/main" id="{9AA7CDEE-2E5E-49AE-8ADC-CFA6AC7037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01CA4-98A9-491D-ADB4-32051F4F8A4B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:a16="http://schemas.microsoft.com/office/drawing/2014/main" id="{27D28F4B-1A1F-4DCC-B1D2-E8D0665E20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:a16="http://schemas.microsoft.com/office/drawing/2014/main" id="{53EEC235-81F0-44C9-A4F4-BBE28256A1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69B0D-3364-4BA1-B72E-2835A34ED18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437984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AA3B9C9F-A7F2-498F-B73C-7676D33639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>
            <a:extLst>
              <a:ext uri="{FF2B5EF4-FFF2-40B4-BE49-F238E27FC236}">
                <a16:creationId xmlns:a16="http://schemas.microsoft.com/office/drawing/2014/main" id="{4D74175A-3A6E-4417-8EB4-5993190C5D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>
            <a:extLst>
              <a:ext uri="{FF2B5EF4-FFF2-40B4-BE49-F238E27FC236}">
                <a16:creationId xmlns:a16="http://schemas.microsoft.com/office/drawing/2014/main" id="{14F9AE07-489E-47B4-A716-682EB3DBD2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:a16="http://schemas.microsoft.com/office/drawing/2014/main" id="{56AE1914-8BEE-4149-A700-8610021019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01CA4-98A9-491D-ADB4-32051F4F8A4B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:a16="http://schemas.microsoft.com/office/drawing/2014/main" id="{70D3E2A0-84EE-4931-B583-D0299C5143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:a16="http://schemas.microsoft.com/office/drawing/2014/main" id="{09B96323-7250-408F-9D07-C923CCAC9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69B0D-3364-4BA1-B72E-2835A34ED18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258284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466D15F3-3FA9-4E7E-858D-6026F8537C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:a16="http://schemas.microsoft.com/office/drawing/2014/main" id="{3F9BA68D-5405-4FDC-89FA-4B9A937AD4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1BA27B62-1A0C-4EE3-BF1D-85D1162ED91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601CA4-98A9-491D-ADB4-32051F4F8A4B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E962276A-7DC7-4102-8339-594035095F2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199D0EB6-7DEF-4733-8833-57560DF08A0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469B0D-3364-4BA1-B72E-2835A34ED18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5546515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Группа 6">
            <a:extLst>
              <a:ext uri="{FF2B5EF4-FFF2-40B4-BE49-F238E27FC236}">
                <a16:creationId xmlns:a16="http://schemas.microsoft.com/office/drawing/2014/main" id="{7C2B3C92-D59A-4BB3-807F-6F37DCF2FE42}"/>
              </a:ext>
            </a:extLst>
          </p:cNvPr>
          <p:cNvGrpSpPr/>
          <p:nvPr/>
        </p:nvGrpSpPr>
        <p:grpSpPr>
          <a:xfrm>
            <a:off x="3167270" y="1139687"/>
            <a:ext cx="3803372" cy="3457277"/>
            <a:chOff x="3167270" y="1139687"/>
            <a:chExt cx="3803372" cy="3457277"/>
          </a:xfrm>
        </p:grpSpPr>
        <p:pic>
          <p:nvPicPr>
            <p:cNvPr id="5" name="Рисунок 4">
              <a:extLst>
                <a:ext uri="{FF2B5EF4-FFF2-40B4-BE49-F238E27FC236}">
                  <a16:creationId xmlns:a16="http://schemas.microsoft.com/office/drawing/2014/main" id="{363F0FA5-46BE-4673-86F2-777BFF4EF67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67987" y="1337426"/>
              <a:ext cx="3702655" cy="3259538"/>
            </a:xfrm>
            <a:prstGeom prst="rect">
              <a:avLst/>
            </a:prstGeom>
          </p:spPr>
        </p:pic>
        <p:sp>
          <p:nvSpPr>
            <p:cNvPr id="6" name="Прямоугольник 5">
              <a:extLst>
                <a:ext uri="{FF2B5EF4-FFF2-40B4-BE49-F238E27FC236}">
                  <a16:creationId xmlns:a16="http://schemas.microsoft.com/office/drawing/2014/main" id="{5051BEC2-1A1C-46BB-BC60-DF6B20037D58}"/>
                </a:ext>
              </a:extLst>
            </p:cNvPr>
            <p:cNvSpPr/>
            <p:nvPr/>
          </p:nvSpPr>
          <p:spPr>
            <a:xfrm>
              <a:off x="3167270" y="1139687"/>
              <a:ext cx="583095" cy="55659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AC94B0CC-1543-4150-9977-D26DD37FB7BA}"/>
              </a:ext>
            </a:extLst>
          </p:cNvPr>
          <p:cNvSpPr txBox="1"/>
          <p:nvPr/>
        </p:nvSpPr>
        <p:spPr>
          <a:xfrm>
            <a:off x="970739" y="5441314"/>
            <a:ext cx="10250522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Recombinant plasmid for co-expression of MTS1338 and GFP in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. smegmatis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the control plasmid (pMV261-GFP) lacked the MTS1338 cassette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ru-R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6592940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7</Words>
  <Application>Microsoft Office PowerPoint</Application>
  <PresentationFormat>Широкоэкранный</PresentationFormat>
  <Paragraphs>1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4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Тема Office</vt:lpstr>
      <vt:lpstr>Презентация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Татьяна Ажикина</dc:creator>
  <cp:lastModifiedBy>Татьяна Ажикина</cp:lastModifiedBy>
  <cp:revision>4</cp:revision>
  <dcterms:created xsi:type="dcterms:W3CDTF">2020-09-27T16:37:17Z</dcterms:created>
  <dcterms:modified xsi:type="dcterms:W3CDTF">2021-01-31T16:28:27Z</dcterms:modified>
</cp:coreProperties>
</file>